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36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7312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694595" y="6443701"/>
            <a:ext cx="558118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Supplemental Figure S12. The shape and surface electrostatic charges of ORF57-CTD differ from that of ICP27-CTD.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(A and B) The shape and electrostatic calculations of a monomeric structure in dimerized ORF57-CTD (A) and ICP27-CTD (B, PDB ID: 4yxp) calculated by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PyMol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 with the APBS with180˚ rotation, red, negative charge; blue, positive charge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14634" y="403237"/>
            <a:ext cx="2995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578" y="762911"/>
            <a:ext cx="6044019" cy="2479774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76578" y="897770"/>
            <a:ext cx="811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RF57</a:t>
            </a:r>
            <a:endParaRPr lang="zh-CN" altLang="en-US" sz="14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60" y="3242685"/>
            <a:ext cx="6209849" cy="275068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76577" y="3527440"/>
            <a:ext cx="8111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ICP27</a:t>
            </a:r>
            <a:endParaRPr lang="zh-CN" altLang="en-US" sz="14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9" name="文本框 6"/>
          <p:cNvSpPr txBox="1"/>
          <p:nvPr/>
        </p:nvSpPr>
        <p:spPr>
          <a:xfrm>
            <a:off x="376578" y="3158108"/>
            <a:ext cx="2995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1426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7</TotalTime>
  <Words>73</Words>
  <Application>Microsoft Office PowerPoint</Application>
  <PresentationFormat>全屏显示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9</cp:revision>
  <cp:lastPrinted>2018-01-18T18:33:05Z</cp:lastPrinted>
  <dcterms:created xsi:type="dcterms:W3CDTF">2017-06-08T22:39:00Z</dcterms:created>
  <dcterms:modified xsi:type="dcterms:W3CDTF">2018-07-26T12:45:45Z</dcterms:modified>
</cp:coreProperties>
</file>